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6281"/>
  </p:normalViewPr>
  <p:slideViewPr>
    <p:cSldViewPr snapToGrid="0" snapToObjects="1" showGuides="1">
      <p:cViewPr varScale="1">
        <p:scale>
          <a:sx n="83" d="100"/>
          <a:sy n="83" d="100"/>
        </p:scale>
        <p:origin x="658" y="77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4B22100-1E68-BA77-6441-E15C3A32A75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AA8A2E2D-026E-011D-285A-BA76C198B55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ES_tradn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9FDDB76-446D-8A95-F6CE-A3F58C9189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A55CF-F23D-3D4B-B165-F1AB34F4CF80}" type="datetimeFigureOut">
              <a:rPr lang="es-ES_tradnl" smtClean="0"/>
              <a:t>12/09/2022</a:t>
            </a:fld>
            <a:endParaRPr lang="es-ES_tradn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ABC2B4C7-903E-308A-699E-A7D9C48E8F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F855DDA-2DFC-CF2B-C868-449EA5ECFB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2857-90F8-AA49-923A-E8E0E5F7BA2A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4404914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D8D021F-3002-AFB1-0EB2-FDA344FDC0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3F508221-3C05-1543-DF20-B624E0B0389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S_tradn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F532189-F1B2-AAC4-BAFB-B9A03C8F61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A55CF-F23D-3D4B-B165-F1AB34F4CF80}" type="datetimeFigureOut">
              <a:rPr lang="es-ES_tradnl" smtClean="0"/>
              <a:t>12/09/2022</a:t>
            </a:fld>
            <a:endParaRPr lang="es-ES_tradn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A989CAE9-934C-C6E6-12A6-E7A43C03CE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96FA69D-C3B6-DB14-3FEF-E6B14C888E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2857-90F8-AA49-923A-E8E0E5F7BA2A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1458028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F15BBDE7-80DA-A8D9-30AB-F1DBA467A3E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A4A035E3-4AFF-EE1C-CA1C-79603C9D5B4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S_tradn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B2A110A-6801-9DEF-3F9D-7EBF4217CB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A55CF-F23D-3D4B-B165-F1AB34F4CF80}" type="datetimeFigureOut">
              <a:rPr lang="es-ES_tradnl" smtClean="0"/>
              <a:t>12/09/2022</a:t>
            </a:fld>
            <a:endParaRPr lang="es-ES_tradn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27D99B0-B056-FC54-62C3-60125A16D4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A50186D-430F-9705-17B1-17E5A83A68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2857-90F8-AA49-923A-E8E0E5F7BA2A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6617407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1BB3DCC-37C1-3BDF-CCE6-3DA3D59F53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8647563D-494C-9D16-9FD6-A38742FFEA4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S_tradn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7193FC4-7150-EAD7-22C8-6BC5ACF50D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A55CF-F23D-3D4B-B165-F1AB34F4CF80}" type="datetimeFigureOut">
              <a:rPr lang="es-ES_tradnl" smtClean="0"/>
              <a:t>12/09/2022</a:t>
            </a:fld>
            <a:endParaRPr lang="es-ES_tradn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007C18E-467F-BC3F-E50D-F5BA1EC4CC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B392DFE-CB71-A204-250C-EFCB96DB7D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2857-90F8-AA49-923A-E8E0E5F7BA2A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1190751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C0E7663-1D02-0DCB-698C-68FBEF60A8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CA38146D-7786-E624-0E17-1392C4CA4E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94408A0-4F6F-5006-8F37-DA795AD3F4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A55CF-F23D-3D4B-B165-F1AB34F4CF80}" type="datetimeFigureOut">
              <a:rPr lang="es-ES_tradnl" smtClean="0"/>
              <a:t>12/09/2022</a:t>
            </a:fld>
            <a:endParaRPr lang="es-ES_tradn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6C93F5F-BB9A-167F-4050-44057996AF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917E378-A295-8A7C-EF8B-2B5A316E29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2857-90F8-AA49-923A-E8E0E5F7BA2A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0568298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5278740-DB0B-3584-C17E-CFA8F5F788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D878B836-C807-F86E-DA40-11980C67AA6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S_tradnl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92A1D698-4F19-31B6-EEA7-A4C5C1B99BD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S_tradnl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CFC8E7B8-F43F-AA48-53AD-75143EED43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A55CF-F23D-3D4B-B165-F1AB34F4CF80}" type="datetimeFigureOut">
              <a:rPr lang="es-ES_tradnl" smtClean="0"/>
              <a:t>12/09/2022</a:t>
            </a:fld>
            <a:endParaRPr lang="es-ES_tradn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E00BFAA3-9FD9-A2DA-A7C6-7687A5801F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4FC8926E-D673-FA08-C675-CCFADCBA84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2857-90F8-AA49-923A-E8E0E5F7BA2A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7157514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ACB1B6E-4A99-0F30-C189-68365E0747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4FD7E657-296B-3109-6517-52A7819D66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D95143EF-4301-1F07-6543-A1871F6A550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S_tradnl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AE3F6EA2-26FB-C8CC-B678-B27AD184E8A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246DFAF3-474D-98A4-2200-9E9A7E0B519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S_tradnl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9DB379C1-C435-D4D7-E0B2-76F3476EC7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A55CF-F23D-3D4B-B165-F1AB34F4CF80}" type="datetimeFigureOut">
              <a:rPr lang="es-ES_tradnl" smtClean="0"/>
              <a:t>12/09/2022</a:t>
            </a:fld>
            <a:endParaRPr lang="es-ES_tradnl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25AB155C-B87F-8E5F-F617-4232FD540C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2C24BE66-A34C-DCC9-DA14-0637D9BC59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2857-90F8-AA49-923A-E8E0E5F7BA2A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1764141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8C419C7-102A-DCB3-65F5-93FA559C1D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37887A49-E1C5-9F0D-02FB-F53853A85E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A55CF-F23D-3D4B-B165-F1AB34F4CF80}" type="datetimeFigureOut">
              <a:rPr lang="es-ES_tradnl" smtClean="0"/>
              <a:t>12/09/2022</a:t>
            </a:fld>
            <a:endParaRPr lang="es-ES_tradnl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4E502F85-2F69-C7E4-E524-9545FFB996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F5A2D026-E44F-C20C-70CB-4E1540FA2C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2857-90F8-AA49-923A-E8E0E5F7BA2A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4885871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B73692B7-56BF-F723-84FE-A71CACB903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A55CF-F23D-3D4B-B165-F1AB34F4CF80}" type="datetimeFigureOut">
              <a:rPr lang="es-ES_tradnl" smtClean="0"/>
              <a:t>12/09/2022</a:t>
            </a:fld>
            <a:endParaRPr lang="es-ES_tradnl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E0469BB5-1CC9-FFA5-EDCE-BCC5C31D7E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49DDBDD4-753C-930C-E2CD-6E1EB89B72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2857-90F8-AA49-923A-E8E0E5F7BA2A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5925900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96EFE30-8205-CFDA-83F7-C27383EB32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A11CB3D5-1C05-782E-5740-B7D8B425F9E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S_tradnl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B494B9DA-BCDD-BA19-5AA8-05FD8DDD65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E190139F-65B6-9590-D8C8-E4D28D2CE8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A55CF-F23D-3D4B-B165-F1AB34F4CF80}" type="datetimeFigureOut">
              <a:rPr lang="es-ES_tradnl" smtClean="0"/>
              <a:t>12/09/2022</a:t>
            </a:fld>
            <a:endParaRPr lang="es-ES_tradn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F4B74B91-DC27-08C7-1788-9AEE5A50B2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7DFE7921-503D-E391-286F-91749F2022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2857-90F8-AA49-923A-E8E0E5F7BA2A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2885678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08EBC70-3873-3F5F-5561-B89A6329F8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CFBE02E0-5E0F-58FF-38FF-C75F2B000D0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_tradnl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E24424EF-A30A-6682-95DB-B3FFD6AC38F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1864A578-3404-2826-1475-DB85E48217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A55CF-F23D-3D4B-B165-F1AB34F4CF80}" type="datetimeFigureOut">
              <a:rPr lang="es-ES_tradnl" smtClean="0"/>
              <a:t>12/09/2022</a:t>
            </a:fld>
            <a:endParaRPr lang="es-ES_tradn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40ADFCF4-EFA0-FAAD-D735-E12DAC912A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58E2435D-3B93-E21E-F191-C2419BA147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2857-90F8-AA49-923A-E8E0E5F7BA2A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4408196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87795C03-791A-8167-CE52-3D7BDAD77C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2524C4A2-60CB-3A6F-DBE2-04EA0DB661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S_tradn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74573C80-FBA8-C71F-2079-E4BF4513657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6A55CF-F23D-3D4B-B165-F1AB34F4CF80}" type="datetimeFigureOut">
              <a:rPr lang="es-ES_tradnl" smtClean="0"/>
              <a:t>12/09/2022</a:t>
            </a:fld>
            <a:endParaRPr lang="es-ES_tradn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D625E33-1E1F-28DC-AD42-DB7188659C7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_tradn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57F30FD-FD01-3899-8993-4D5B0314909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02857-90F8-AA49-923A-E8E0E5F7BA2A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7845198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23 CuadroTexto"/>
          <p:cNvSpPr txBox="1"/>
          <p:nvPr/>
        </p:nvSpPr>
        <p:spPr>
          <a:xfrm>
            <a:off x="2278374" y="2974438"/>
            <a:ext cx="713009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Schematic representation of the experimental study design. </a:t>
            </a:r>
            <a:r>
              <a:rPr lang="en-US" sz="1100" dirty="0">
                <a:solidFill>
                  <a:srgbClr val="0099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eces will be collected daily from this point.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2" name="Grupo 21">
            <a:extLst>
              <a:ext uri="{FF2B5EF4-FFF2-40B4-BE49-F238E27FC236}">
                <a16:creationId xmlns:a16="http://schemas.microsoft.com/office/drawing/2014/main" id="{B3C821AE-68ED-094E-A9BF-4121E9D02E75}"/>
              </a:ext>
            </a:extLst>
          </p:cNvPr>
          <p:cNvGrpSpPr/>
          <p:nvPr/>
        </p:nvGrpSpPr>
        <p:grpSpPr>
          <a:xfrm>
            <a:off x="1857438" y="813128"/>
            <a:ext cx="8199003" cy="2039808"/>
            <a:chOff x="333437" y="813128"/>
            <a:chExt cx="8199003" cy="2039808"/>
          </a:xfrm>
        </p:grpSpPr>
        <p:sp>
          <p:nvSpPr>
            <p:cNvPr id="2" name="1 CuadroTexto"/>
            <p:cNvSpPr txBox="1"/>
            <p:nvPr/>
          </p:nvSpPr>
          <p:spPr>
            <a:xfrm>
              <a:off x="333437" y="1432533"/>
              <a:ext cx="70403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200" dirty="0" err="1">
                  <a:latin typeface="Arial Narrow" panose="020B0606020202030204" pitchFamily="34" charset="0"/>
                  <a:cs typeface="Arial" panose="020B0604020202020204" pitchFamily="34" charset="0"/>
                </a:rPr>
                <a:t>Mice</a:t>
              </a:r>
              <a:endParaRPr lang="es-ES" sz="12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s-ES" sz="1200" dirty="0" err="1">
                  <a:latin typeface="Arial Narrow" panose="020B0606020202030204" pitchFamily="34" charset="0"/>
                  <a:cs typeface="Arial" panose="020B0604020202020204" pitchFamily="34" charset="0"/>
                </a:rPr>
                <a:t>reception</a:t>
              </a:r>
              <a:endParaRPr lang="es-ES" sz="12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4 CuadroTexto"/>
            <p:cNvSpPr txBox="1"/>
            <p:nvPr/>
          </p:nvSpPr>
          <p:spPr>
            <a:xfrm>
              <a:off x="1715736" y="1484122"/>
              <a:ext cx="69602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200" dirty="0" err="1">
                  <a:latin typeface="Arial Narrow" panose="020B0606020202030204" pitchFamily="34" charset="0"/>
                  <a:cs typeface="Arial" panose="020B0604020202020204" pitchFamily="34" charset="0"/>
                </a:rPr>
                <a:t>Antibiotic</a:t>
              </a:r>
              <a:endParaRPr lang="es-ES" sz="12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s-ES" sz="1200" dirty="0" err="1">
                  <a:latin typeface="Arial Narrow" panose="020B0606020202030204" pitchFamily="34" charset="0"/>
                  <a:cs typeface="Arial" panose="020B0604020202020204" pitchFamily="34" charset="0"/>
                </a:rPr>
                <a:t>cocktail</a:t>
              </a:r>
              <a:endParaRPr lang="es-ES" sz="12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5 CuadroTexto"/>
            <p:cNvSpPr txBox="1"/>
            <p:nvPr/>
          </p:nvSpPr>
          <p:spPr>
            <a:xfrm>
              <a:off x="4611631" y="1487780"/>
              <a:ext cx="18473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endParaRPr lang="es-ES" sz="12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6" name="25 Conector recto"/>
            <p:cNvCxnSpPr>
              <a:cxnSpLocks/>
            </p:cNvCxnSpPr>
            <p:nvPr/>
          </p:nvCxnSpPr>
          <p:spPr>
            <a:xfrm>
              <a:off x="626478" y="2305447"/>
              <a:ext cx="6452281" cy="6864"/>
            </a:xfrm>
            <a:prstGeom prst="line">
              <a:avLst/>
            </a:prstGeom>
            <a:ln w="254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27 Conector recto de flecha"/>
            <p:cNvCxnSpPr/>
            <p:nvPr/>
          </p:nvCxnSpPr>
          <p:spPr>
            <a:xfrm flipH="1">
              <a:off x="627619" y="1959448"/>
              <a:ext cx="1" cy="259077"/>
            </a:xfrm>
            <a:prstGeom prst="straightConnector1">
              <a:avLst/>
            </a:prstGeom>
            <a:ln w="12700"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29 Conector recto"/>
            <p:cNvCxnSpPr/>
            <p:nvPr/>
          </p:nvCxnSpPr>
          <p:spPr>
            <a:xfrm>
              <a:off x="628796" y="2238772"/>
              <a:ext cx="0" cy="144016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30 Conector recto"/>
            <p:cNvCxnSpPr/>
            <p:nvPr/>
          </p:nvCxnSpPr>
          <p:spPr>
            <a:xfrm>
              <a:off x="2063748" y="2238772"/>
              <a:ext cx="0" cy="144016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31 Conector recto"/>
            <p:cNvCxnSpPr/>
            <p:nvPr/>
          </p:nvCxnSpPr>
          <p:spPr>
            <a:xfrm>
              <a:off x="4896897" y="2247553"/>
              <a:ext cx="0" cy="144016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32 Conector recto de flecha"/>
            <p:cNvCxnSpPr/>
            <p:nvPr/>
          </p:nvCxnSpPr>
          <p:spPr>
            <a:xfrm flipH="1">
              <a:off x="2063748" y="1955556"/>
              <a:ext cx="1" cy="259077"/>
            </a:xfrm>
            <a:prstGeom prst="straightConnector1">
              <a:avLst/>
            </a:prstGeom>
            <a:ln w="12700"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33 Conector recto de flecha"/>
            <p:cNvCxnSpPr/>
            <p:nvPr/>
          </p:nvCxnSpPr>
          <p:spPr>
            <a:xfrm flipH="1">
              <a:off x="4896896" y="1955131"/>
              <a:ext cx="1" cy="259077"/>
            </a:xfrm>
            <a:prstGeom prst="straightConnector1">
              <a:avLst/>
            </a:prstGeom>
            <a:ln w="12700"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35 Conector recto de flecha"/>
            <p:cNvCxnSpPr/>
            <p:nvPr/>
          </p:nvCxnSpPr>
          <p:spPr>
            <a:xfrm flipH="1">
              <a:off x="5560489" y="1945787"/>
              <a:ext cx="1" cy="259077"/>
            </a:xfrm>
            <a:prstGeom prst="straightConnector1">
              <a:avLst/>
            </a:prstGeom>
            <a:ln w="12700"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36 Conector recto"/>
            <p:cNvCxnSpPr/>
            <p:nvPr/>
          </p:nvCxnSpPr>
          <p:spPr>
            <a:xfrm>
              <a:off x="5560489" y="2247553"/>
              <a:ext cx="0" cy="144016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37 Conector recto"/>
            <p:cNvCxnSpPr>
              <a:cxnSpLocks/>
            </p:cNvCxnSpPr>
            <p:nvPr/>
          </p:nvCxnSpPr>
          <p:spPr>
            <a:xfrm>
              <a:off x="7083541" y="2247553"/>
              <a:ext cx="0" cy="144016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38 CuadroTexto"/>
            <p:cNvSpPr txBox="1"/>
            <p:nvPr/>
          </p:nvSpPr>
          <p:spPr>
            <a:xfrm>
              <a:off x="899592" y="2391271"/>
              <a:ext cx="81144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200" dirty="0">
                  <a:latin typeface="Arial Narrow" panose="020B0606020202030204" pitchFamily="34" charset="0"/>
                  <a:cs typeface="Arial" panose="020B0604020202020204" pitchFamily="34" charset="0"/>
                </a:rPr>
                <a:t>1 </a:t>
              </a:r>
              <a:r>
                <a:rPr lang="es-ES" sz="1200" dirty="0" err="1">
                  <a:latin typeface="Arial Narrow" panose="020B0606020202030204" pitchFamily="34" charset="0"/>
                  <a:cs typeface="Arial" panose="020B0604020202020204" pitchFamily="34" charset="0"/>
                </a:rPr>
                <a:t>week</a:t>
              </a:r>
              <a:endParaRPr lang="es-ES" sz="12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s-ES" sz="1200" dirty="0" err="1">
                  <a:latin typeface="Arial Narrow" panose="020B0606020202030204" pitchFamily="34" charset="0"/>
                  <a:cs typeface="Arial" panose="020B0604020202020204" pitchFamily="34" charset="0"/>
                </a:rPr>
                <a:t>adaptation</a:t>
              </a:r>
              <a:r>
                <a:rPr lang="es-ES" sz="1200" dirty="0">
                  <a:latin typeface="Arial Narrow" panose="020B060602020203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40" name="39 CuadroTexto"/>
            <p:cNvSpPr txBox="1"/>
            <p:nvPr/>
          </p:nvSpPr>
          <p:spPr>
            <a:xfrm>
              <a:off x="6111557" y="2391271"/>
              <a:ext cx="62068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>
                  <a:latin typeface="Arial Narrow" panose="020B0606020202030204" pitchFamily="34" charset="0"/>
                  <a:cs typeface="Arial" panose="020B0604020202020204" pitchFamily="34" charset="0"/>
                </a:rPr>
                <a:t>1 </a:t>
              </a:r>
              <a:r>
                <a:rPr lang="es-ES" sz="1200" dirty="0" err="1">
                  <a:latin typeface="Arial Narrow" panose="020B0606020202030204" pitchFamily="34" charset="0"/>
                  <a:cs typeface="Arial" panose="020B0604020202020204" pitchFamily="34" charset="0"/>
                </a:rPr>
                <a:t>week</a:t>
              </a:r>
              <a:r>
                <a:rPr lang="es-ES" sz="1200" dirty="0">
                  <a:latin typeface="Arial Narrow" panose="020B060602020203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41" name="40 CuadroTexto"/>
            <p:cNvSpPr txBox="1"/>
            <p:nvPr/>
          </p:nvSpPr>
          <p:spPr>
            <a:xfrm>
              <a:off x="4930660" y="2391271"/>
              <a:ext cx="55656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>
                  <a:latin typeface="Arial Narrow" panose="020B0606020202030204" pitchFamily="34" charset="0"/>
                  <a:cs typeface="Arial" panose="020B0604020202020204" pitchFamily="34" charset="0"/>
                </a:rPr>
                <a:t>2 </a:t>
              </a:r>
              <a:r>
                <a:rPr lang="es-ES" sz="1200" dirty="0" err="1">
                  <a:latin typeface="Arial Narrow" panose="020B0606020202030204" pitchFamily="34" charset="0"/>
                  <a:cs typeface="Arial" panose="020B0604020202020204" pitchFamily="34" charset="0"/>
                </a:rPr>
                <a:t>days</a:t>
              </a:r>
              <a:endParaRPr lang="es-ES" sz="12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41 CuadroTexto"/>
            <p:cNvSpPr txBox="1"/>
            <p:nvPr/>
          </p:nvSpPr>
          <p:spPr>
            <a:xfrm>
              <a:off x="2952696" y="2391271"/>
              <a:ext cx="6832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>
                  <a:latin typeface="Arial Narrow" panose="020B0606020202030204" pitchFamily="34" charset="0"/>
                  <a:cs typeface="Arial" panose="020B0604020202020204" pitchFamily="34" charset="0"/>
                </a:rPr>
                <a:t>3 </a:t>
              </a:r>
              <a:r>
                <a:rPr lang="es-ES" sz="1200" dirty="0" err="1">
                  <a:latin typeface="Arial Narrow" panose="020B0606020202030204" pitchFamily="34" charset="0"/>
                  <a:cs typeface="Arial" panose="020B0604020202020204" pitchFamily="34" charset="0"/>
                </a:rPr>
                <a:t>weeks</a:t>
              </a:r>
              <a:r>
                <a:rPr lang="es-ES" sz="1200" dirty="0">
                  <a:latin typeface="Arial Narrow" panose="020B060602020203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44" name="43 CuadroTexto"/>
            <p:cNvSpPr txBox="1"/>
            <p:nvPr/>
          </p:nvSpPr>
          <p:spPr>
            <a:xfrm>
              <a:off x="6724335" y="1458450"/>
              <a:ext cx="70884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200" dirty="0">
                  <a:latin typeface="Arial Narrow" panose="020B0606020202030204" pitchFamily="34" charset="0"/>
                  <a:cs typeface="Arial" panose="020B0604020202020204" pitchFamily="34" charset="0"/>
                </a:rPr>
                <a:t>Final</a:t>
              </a:r>
            </a:p>
            <a:p>
              <a:pPr algn="ctr"/>
              <a:r>
                <a:rPr lang="es-ES" sz="1200" dirty="0" err="1">
                  <a:latin typeface="Arial Narrow" panose="020B0606020202030204" pitchFamily="34" charset="0"/>
                  <a:cs typeface="Arial" panose="020B0604020202020204" pitchFamily="34" charset="0"/>
                </a:rPr>
                <a:t>collection</a:t>
              </a:r>
              <a:endParaRPr lang="es-ES" sz="12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44 Rectángulo"/>
            <p:cNvSpPr/>
            <p:nvPr/>
          </p:nvSpPr>
          <p:spPr>
            <a:xfrm>
              <a:off x="7519021" y="813128"/>
              <a:ext cx="1013419" cy="156966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>
                  <a:solidFill>
                    <a:srgbClr val="7030A0"/>
                  </a:solidFill>
                  <a:latin typeface="Arial Narrow" panose="020B0606020202030204" pitchFamily="34" charset="0"/>
                  <a:cs typeface="Arial" panose="020B0604020202020204" pitchFamily="34" charset="0"/>
                </a:rPr>
                <a:t>Feces</a:t>
              </a:r>
            </a:p>
            <a:p>
              <a:r>
                <a:rPr lang="en-US" sz="1200" dirty="0">
                  <a:solidFill>
                    <a:srgbClr val="7030A0"/>
                  </a:solidFill>
                  <a:latin typeface="Arial Narrow" panose="020B0606020202030204" pitchFamily="34" charset="0"/>
                  <a:cs typeface="Arial" panose="020B0604020202020204" pitchFamily="34" charset="0"/>
                </a:rPr>
                <a:t>Small intestine</a:t>
              </a:r>
            </a:p>
            <a:p>
              <a:r>
                <a:rPr lang="en-US" sz="1200" dirty="0">
                  <a:solidFill>
                    <a:srgbClr val="7030A0"/>
                  </a:solidFill>
                  <a:latin typeface="Arial Narrow" panose="020B0606020202030204" pitchFamily="34" charset="0"/>
                  <a:cs typeface="Arial" panose="020B0604020202020204" pitchFamily="34" charset="0"/>
                </a:rPr>
                <a:t>     Content</a:t>
              </a:r>
            </a:p>
            <a:p>
              <a:r>
                <a:rPr lang="en-US" sz="1200" dirty="0">
                  <a:solidFill>
                    <a:srgbClr val="7030A0"/>
                  </a:solidFill>
                  <a:latin typeface="Arial Narrow" panose="020B0606020202030204" pitchFamily="34" charset="0"/>
                  <a:cs typeface="Arial" panose="020B0604020202020204" pitchFamily="34" charset="0"/>
                </a:rPr>
                <a:t>     Tissue</a:t>
              </a:r>
            </a:p>
            <a:p>
              <a:r>
                <a:rPr lang="en-US" sz="1200" dirty="0">
                  <a:solidFill>
                    <a:srgbClr val="7030A0"/>
                  </a:solidFill>
                  <a:latin typeface="Arial Narrow" panose="020B0606020202030204" pitchFamily="34" charset="0"/>
                  <a:cs typeface="Arial" panose="020B0604020202020204" pitchFamily="34" charset="0"/>
                </a:rPr>
                <a:t>Large intestine</a:t>
              </a:r>
            </a:p>
            <a:p>
              <a:r>
                <a:rPr lang="en-US" sz="1200" dirty="0">
                  <a:solidFill>
                    <a:srgbClr val="7030A0"/>
                  </a:solidFill>
                  <a:latin typeface="Arial Narrow" panose="020B0606020202030204" pitchFamily="34" charset="0"/>
                  <a:cs typeface="Arial" panose="020B0604020202020204" pitchFamily="34" charset="0"/>
                </a:rPr>
                <a:t>      Content</a:t>
              </a:r>
            </a:p>
            <a:p>
              <a:r>
                <a:rPr lang="en-US" sz="1200" dirty="0">
                  <a:solidFill>
                    <a:srgbClr val="7030A0"/>
                  </a:solidFill>
                  <a:latin typeface="Arial Narrow" panose="020B0606020202030204" pitchFamily="34" charset="0"/>
                  <a:cs typeface="Arial" panose="020B0604020202020204" pitchFamily="34" charset="0"/>
                </a:rPr>
                <a:t>      Tissue</a:t>
              </a:r>
            </a:p>
            <a:p>
              <a:r>
                <a:rPr lang="en-US" sz="1200" dirty="0">
                  <a:solidFill>
                    <a:srgbClr val="7030A0"/>
                  </a:solidFill>
                  <a:latin typeface="Arial Narrow" panose="020B0606020202030204" pitchFamily="34" charset="0"/>
                  <a:cs typeface="Arial" panose="020B0604020202020204" pitchFamily="34" charset="0"/>
                </a:rPr>
                <a:t>Blood </a:t>
              </a:r>
            </a:p>
          </p:txBody>
        </p:sp>
        <p:cxnSp>
          <p:nvCxnSpPr>
            <p:cNvPr id="35" name="34 Conector recto de flecha"/>
            <p:cNvCxnSpPr/>
            <p:nvPr/>
          </p:nvCxnSpPr>
          <p:spPr>
            <a:xfrm flipH="1">
              <a:off x="7080888" y="1946843"/>
              <a:ext cx="1" cy="259077"/>
            </a:xfrm>
            <a:prstGeom prst="straightConnector1">
              <a:avLst/>
            </a:prstGeom>
            <a:ln w="12700"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59" name="58 Grupo"/>
            <p:cNvGrpSpPr/>
            <p:nvPr/>
          </p:nvGrpSpPr>
          <p:grpSpPr>
            <a:xfrm>
              <a:off x="7400404" y="971437"/>
              <a:ext cx="400968" cy="1260000"/>
              <a:chOff x="7564585" y="851005"/>
              <a:chExt cx="400968" cy="1260000"/>
            </a:xfrm>
          </p:grpSpPr>
          <p:cxnSp>
            <p:nvCxnSpPr>
              <p:cNvPr id="47" name="46 Conector recto"/>
              <p:cNvCxnSpPr/>
              <p:nvPr/>
            </p:nvCxnSpPr>
            <p:spPr>
              <a:xfrm>
                <a:off x="7627875" y="851005"/>
                <a:ext cx="0" cy="1260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" name="47 Conector recto"/>
              <p:cNvCxnSpPr/>
              <p:nvPr/>
            </p:nvCxnSpPr>
            <p:spPr>
              <a:xfrm>
                <a:off x="7621937" y="852371"/>
                <a:ext cx="108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48 Conector recto"/>
              <p:cNvCxnSpPr/>
              <p:nvPr/>
            </p:nvCxnSpPr>
            <p:spPr>
              <a:xfrm>
                <a:off x="7848376" y="1197894"/>
                <a:ext cx="108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" name="49 Conector recto"/>
              <p:cNvCxnSpPr/>
              <p:nvPr/>
            </p:nvCxnSpPr>
            <p:spPr>
              <a:xfrm>
                <a:off x="7621937" y="1016161"/>
                <a:ext cx="108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50 Conector recto"/>
              <p:cNvCxnSpPr/>
              <p:nvPr/>
            </p:nvCxnSpPr>
            <p:spPr>
              <a:xfrm>
                <a:off x="7857553" y="1375274"/>
                <a:ext cx="108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51 Conector recto"/>
              <p:cNvCxnSpPr/>
              <p:nvPr/>
            </p:nvCxnSpPr>
            <p:spPr>
              <a:xfrm>
                <a:off x="7625604" y="1585891"/>
                <a:ext cx="108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" name="52 Conector recto"/>
              <p:cNvCxnSpPr/>
              <p:nvPr/>
            </p:nvCxnSpPr>
            <p:spPr>
              <a:xfrm>
                <a:off x="7855980" y="1758318"/>
                <a:ext cx="108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53 Conector recto"/>
              <p:cNvCxnSpPr/>
              <p:nvPr/>
            </p:nvCxnSpPr>
            <p:spPr>
              <a:xfrm>
                <a:off x="7855980" y="1925933"/>
                <a:ext cx="108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54 Conector recto"/>
              <p:cNvCxnSpPr/>
              <p:nvPr/>
            </p:nvCxnSpPr>
            <p:spPr>
              <a:xfrm>
                <a:off x="7626601" y="2109943"/>
                <a:ext cx="108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55 Conector recto"/>
              <p:cNvCxnSpPr/>
              <p:nvPr/>
            </p:nvCxnSpPr>
            <p:spPr>
              <a:xfrm>
                <a:off x="7564585" y="1585547"/>
                <a:ext cx="108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0" name="59 CuadroTexto"/>
            <p:cNvSpPr txBox="1"/>
            <p:nvPr/>
          </p:nvSpPr>
          <p:spPr>
            <a:xfrm>
              <a:off x="5431287" y="2360889"/>
              <a:ext cx="2584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s-ES"/>
              </a:defPPr>
              <a:lvl1pPr>
                <a:defRPr>
                  <a:solidFill>
                    <a:srgbClr val="009900"/>
                  </a:solidFill>
                </a:defRPr>
              </a:lvl1pPr>
            </a:lstStyle>
            <a:p>
              <a:r>
                <a:rPr lang="es-ES" dirty="0">
                  <a:latin typeface="Arial Narrow" panose="020B0606020202030204" pitchFamily="34" charset="0"/>
                </a:rPr>
                <a:t>*</a:t>
              </a:r>
            </a:p>
          </p:txBody>
        </p:sp>
        <p:sp>
          <p:nvSpPr>
            <p:cNvPr id="58" name="4 CuadroTexto">
              <a:extLst>
                <a:ext uri="{FF2B5EF4-FFF2-40B4-BE49-F238E27FC236}">
                  <a16:creationId xmlns:a16="http://schemas.microsoft.com/office/drawing/2014/main" id="{63A7CBCB-3EA8-7C48-A0DA-8AFACBEC30CD}"/>
                </a:ext>
              </a:extLst>
            </p:cNvPr>
            <p:cNvSpPr txBox="1"/>
            <p:nvPr/>
          </p:nvSpPr>
          <p:spPr>
            <a:xfrm>
              <a:off x="4221164" y="1463801"/>
              <a:ext cx="101341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200" dirty="0">
                  <a:latin typeface="Arial Narrow" panose="020B0606020202030204" pitchFamily="34" charset="0"/>
                  <a:cs typeface="Arial" panose="020B0604020202020204" pitchFamily="34" charset="0"/>
                </a:rPr>
                <a:t>Fecal </a:t>
              </a:r>
            </a:p>
            <a:p>
              <a:pPr algn="ctr"/>
              <a:r>
                <a:rPr lang="es-ES" sz="1200" dirty="0" err="1">
                  <a:latin typeface="Arial Narrow" panose="020B0606020202030204" pitchFamily="34" charset="0"/>
                  <a:cs typeface="Arial" panose="020B0604020202020204" pitchFamily="34" charset="0"/>
                </a:rPr>
                <a:t>transplantation</a:t>
              </a:r>
              <a:endParaRPr lang="es-ES" sz="12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4 CuadroTexto">
              <a:extLst>
                <a:ext uri="{FF2B5EF4-FFF2-40B4-BE49-F238E27FC236}">
                  <a16:creationId xmlns:a16="http://schemas.microsoft.com/office/drawing/2014/main" id="{DCE693BA-C5A1-704A-844A-BC4FCFC0AED0}"/>
                </a:ext>
              </a:extLst>
            </p:cNvPr>
            <p:cNvSpPr txBox="1"/>
            <p:nvPr/>
          </p:nvSpPr>
          <p:spPr>
            <a:xfrm>
              <a:off x="5215683" y="1444364"/>
              <a:ext cx="68961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200" dirty="0">
                  <a:latin typeface="Arial Narrow" panose="020B0606020202030204" pitchFamily="34" charset="0"/>
                  <a:cs typeface="Arial" panose="020B0604020202020204" pitchFamily="34" charset="0"/>
                </a:rPr>
                <a:t>Viral</a:t>
              </a:r>
            </a:p>
            <a:p>
              <a:pPr algn="ctr"/>
              <a:r>
                <a:rPr lang="es-ES" sz="1200" dirty="0">
                  <a:latin typeface="Arial Narrow" panose="020B0606020202030204" pitchFamily="34" charset="0"/>
                  <a:cs typeface="Arial" panose="020B0604020202020204" pitchFamily="34" charset="0"/>
                </a:rPr>
                <a:t> </a:t>
              </a:r>
              <a:r>
                <a:rPr lang="es-ES" sz="1200" dirty="0" err="1">
                  <a:latin typeface="Arial Narrow" panose="020B0606020202030204" pitchFamily="34" charset="0"/>
                  <a:cs typeface="Arial" panose="020B0604020202020204" pitchFamily="34" charset="0"/>
                </a:rPr>
                <a:t>infection</a:t>
              </a:r>
              <a:endParaRPr lang="es-ES" sz="1200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57408001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56</Words>
  <Application>Microsoft Office PowerPoint</Application>
  <PresentationFormat>Widescreen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Arial Narrow</vt:lpstr>
      <vt:lpstr>Calibri</vt:lpstr>
      <vt:lpstr>Calibri Light</vt:lpstr>
      <vt:lpstr>Tema de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icrosoft Office User</dc:creator>
  <cp:lastModifiedBy>MDPI-76</cp:lastModifiedBy>
  <cp:revision>3</cp:revision>
  <dcterms:created xsi:type="dcterms:W3CDTF">2022-08-23T08:13:19Z</dcterms:created>
  <dcterms:modified xsi:type="dcterms:W3CDTF">2022-09-12T09:15:12Z</dcterms:modified>
</cp:coreProperties>
</file>